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83" r:id="rId2"/>
  </p:sldIdLst>
  <p:sldSz cx="6858000" cy="9144000" type="screen4x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015" autoAdjust="0"/>
    <p:restoredTop sz="80062"/>
  </p:normalViewPr>
  <p:slideViewPr>
    <p:cSldViewPr snapToGrid="0" snapToObjects="1">
      <p:cViewPr varScale="1">
        <p:scale>
          <a:sx n="85" d="100"/>
          <a:sy n="85" d="100"/>
        </p:scale>
        <p:origin x="-2724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020B4F-419C-914F-8D8C-068A43549A34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AA33D8-C132-3F44-82EC-6FC4CA8054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826100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9C4681-39C4-3B4D-9204-BD06B6CAA7B4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703638" y="857250"/>
            <a:ext cx="173672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BF9D42-348E-484A-8D7A-21D6BE5571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8803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5408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7887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3034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09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6187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9859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6184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02605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4235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2913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9525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13201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正方形/長方形 90">
            <a:extLst>
              <a:ext uri="{FF2B5EF4-FFF2-40B4-BE49-F238E27FC236}">
                <a16:creationId xmlns="" xmlns:a16="http://schemas.microsoft.com/office/drawing/2014/main" id="{8B2F0DB2-38AD-5946-864B-7E113C3446EF}"/>
              </a:ext>
            </a:extLst>
          </p:cNvPr>
          <p:cNvSpPr/>
          <p:nvPr/>
        </p:nvSpPr>
        <p:spPr bwMode="auto">
          <a:xfrm>
            <a:off x="1955944" y="3851050"/>
            <a:ext cx="1598376" cy="216059"/>
          </a:xfrm>
          <a:prstGeom prst="rect">
            <a:avLst/>
          </a:prstGeom>
          <a:solidFill>
            <a:schemeClr val="accent5"/>
          </a:solidFill>
          <a:ln w="1588" cap="flat">
            <a:noFill/>
            <a:prstDash val="solid"/>
            <a:bevel/>
            <a:headEnd/>
            <a:tailEnd/>
          </a:ln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l"/>
            <a:endParaRPr kumimoji="1" lang="ja-JP" altLang="en-US" sz="1000"/>
          </a:p>
        </p:txBody>
      </p:sp>
      <p:sp>
        <p:nvSpPr>
          <p:cNvPr id="92" name="正方形/長方形 91">
            <a:extLst>
              <a:ext uri="{FF2B5EF4-FFF2-40B4-BE49-F238E27FC236}">
                <a16:creationId xmlns="" xmlns:a16="http://schemas.microsoft.com/office/drawing/2014/main" id="{DC47CF23-EF9F-D04C-BF6B-8E5FAEB408E7}"/>
              </a:ext>
            </a:extLst>
          </p:cNvPr>
          <p:cNvSpPr/>
          <p:nvPr/>
        </p:nvSpPr>
        <p:spPr bwMode="auto">
          <a:xfrm>
            <a:off x="1964178" y="4160717"/>
            <a:ext cx="32400" cy="216059"/>
          </a:xfrm>
          <a:prstGeom prst="rect">
            <a:avLst/>
          </a:prstGeom>
          <a:solidFill>
            <a:schemeClr val="accent2"/>
          </a:solidFill>
          <a:ln w="1588" cap="flat">
            <a:noFill/>
            <a:prstDash val="solid"/>
            <a:bevel/>
            <a:headEnd/>
            <a:tailEnd/>
          </a:ln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l"/>
            <a:endParaRPr kumimoji="1" lang="ja-JP" altLang="en-US" sz="1000"/>
          </a:p>
        </p:txBody>
      </p:sp>
      <p:cxnSp>
        <p:nvCxnSpPr>
          <p:cNvPr id="19" name="直線コネクタ 18">
            <a:extLst>
              <a:ext uri="{FF2B5EF4-FFF2-40B4-BE49-F238E27FC236}">
                <a16:creationId xmlns="" xmlns:a16="http://schemas.microsoft.com/office/drawing/2014/main" id="{055C0992-EA11-604F-90B4-6B7E257434A7}"/>
              </a:ext>
            </a:extLst>
          </p:cNvPr>
          <p:cNvCxnSpPr>
            <a:cxnSpLocks/>
          </p:cNvCxnSpPr>
          <p:nvPr/>
        </p:nvCxnSpPr>
        <p:spPr>
          <a:xfrm>
            <a:off x="2823819" y="1527055"/>
            <a:ext cx="0" cy="1063391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線コネクタ 66">
            <a:extLst>
              <a:ext uri="{FF2B5EF4-FFF2-40B4-BE49-F238E27FC236}">
                <a16:creationId xmlns="" xmlns:a16="http://schemas.microsoft.com/office/drawing/2014/main" id="{77CB8EC4-E241-7743-B9D7-DD2147D4370C}"/>
              </a:ext>
            </a:extLst>
          </p:cNvPr>
          <p:cNvCxnSpPr>
            <a:cxnSpLocks/>
          </p:cNvCxnSpPr>
          <p:nvPr/>
        </p:nvCxnSpPr>
        <p:spPr>
          <a:xfrm>
            <a:off x="3695635" y="1527055"/>
            <a:ext cx="0" cy="1056572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正方形/長方形 42">
            <a:extLst>
              <a:ext uri="{FF2B5EF4-FFF2-40B4-BE49-F238E27FC236}">
                <a16:creationId xmlns="" xmlns:a16="http://schemas.microsoft.com/office/drawing/2014/main" id="{FF364B5C-1334-3244-9BD9-796772A2E5E5}"/>
              </a:ext>
            </a:extLst>
          </p:cNvPr>
          <p:cNvSpPr/>
          <p:nvPr/>
        </p:nvSpPr>
        <p:spPr bwMode="auto">
          <a:xfrm>
            <a:off x="1955558" y="1816259"/>
            <a:ext cx="2299482" cy="216059"/>
          </a:xfrm>
          <a:prstGeom prst="rect">
            <a:avLst/>
          </a:prstGeom>
          <a:solidFill>
            <a:schemeClr val="accent5"/>
          </a:solidFill>
          <a:ln w="1588" cap="flat">
            <a:noFill/>
            <a:prstDash val="solid"/>
            <a:bevel/>
            <a:headEnd/>
            <a:tailEnd/>
          </a:ln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l"/>
            <a:endParaRPr kumimoji="1" lang="ja-JP" altLang="en-US" sz="1000"/>
          </a:p>
        </p:txBody>
      </p:sp>
      <p:sp>
        <p:nvSpPr>
          <p:cNvPr id="5" name="テキスト ボックス 560">
            <a:extLst>
              <a:ext uri="{FF2B5EF4-FFF2-40B4-BE49-F238E27FC236}">
                <a16:creationId xmlns="" xmlns:a16="http://schemas.microsoft.com/office/drawing/2014/main" id="{5E07C2CE-D470-454D-991D-FA476B1791E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3663" y="6165283"/>
            <a:ext cx="4497642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 Fig. </a:t>
            </a:r>
            <a:r>
              <a:rPr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mene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linoleic </a:t>
            </a:r>
            <a:r>
              <a:rPr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droperoxide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liminating activity of</a:t>
            </a:r>
          </a:p>
          <a:p>
            <a:pPr eaLnBrk="1" hangingPunct="1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before or after heating cells of  </a:t>
            </a:r>
            <a:r>
              <a:rPr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plan.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1-2.</a:t>
            </a:r>
          </a:p>
        </p:txBody>
      </p:sp>
      <p:sp>
        <p:nvSpPr>
          <p:cNvPr id="128" name="Rectangle 81"/>
          <p:cNvSpPr>
            <a:spLocks noChangeArrowheads="1"/>
          </p:cNvSpPr>
          <p:nvPr/>
        </p:nvSpPr>
        <p:spPr bwMode="auto">
          <a:xfrm>
            <a:off x="3834385" y="5469893"/>
            <a:ext cx="163017" cy="158943"/>
          </a:xfrm>
          <a:prstGeom prst="rect">
            <a:avLst/>
          </a:prstGeom>
          <a:solidFill>
            <a:srgbClr val="ED7D3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1" name="Rectangle 84"/>
          <p:cNvSpPr>
            <a:spLocks noChangeArrowheads="1"/>
          </p:cNvSpPr>
          <p:nvPr/>
        </p:nvSpPr>
        <p:spPr bwMode="auto">
          <a:xfrm>
            <a:off x="1285881" y="5469893"/>
            <a:ext cx="163017" cy="163017"/>
          </a:xfrm>
          <a:prstGeom prst="rect">
            <a:avLst/>
          </a:prstGeom>
          <a:solidFill>
            <a:srgbClr val="5B9BD5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5" name="テキスト ボックス 2"/>
          <p:cNvSpPr txBox="1"/>
          <p:nvPr/>
        </p:nvSpPr>
        <p:spPr>
          <a:xfrm>
            <a:off x="3997401" y="5418559"/>
            <a:ext cx="194693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heating treatment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テキスト ボックス 2"/>
          <p:cNvSpPr txBox="1"/>
          <p:nvPr/>
        </p:nvSpPr>
        <p:spPr>
          <a:xfrm>
            <a:off x="1454599" y="5418559"/>
            <a:ext cx="18106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fore heating treatment</a:t>
            </a:r>
          </a:p>
        </p:txBody>
      </p:sp>
      <p:sp>
        <p:nvSpPr>
          <p:cNvPr id="44" name="正方形/長方形 43">
            <a:extLst>
              <a:ext uri="{FF2B5EF4-FFF2-40B4-BE49-F238E27FC236}">
                <a16:creationId xmlns="" xmlns:a16="http://schemas.microsoft.com/office/drawing/2014/main" id="{CFF92F02-B883-B144-AAE1-D5EF8291E856}"/>
              </a:ext>
            </a:extLst>
          </p:cNvPr>
          <p:cNvSpPr/>
          <p:nvPr/>
        </p:nvSpPr>
        <p:spPr bwMode="auto">
          <a:xfrm>
            <a:off x="1955944" y="2125926"/>
            <a:ext cx="32400" cy="216059"/>
          </a:xfrm>
          <a:prstGeom prst="rect">
            <a:avLst/>
          </a:prstGeom>
          <a:solidFill>
            <a:schemeClr val="accent2"/>
          </a:solidFill>
          <a:ln w="1588" cap="flat">
            <a:noFill/>
            <a:prstDash val="solid"/>
            <a:bevel/>
            <a:headEnd/>
            <a:tailEnd/>
          </a:ln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l"/>
            <a:endParaRPr kumimoji="1" lang="ja-JP" altLang="en-US" sz="1000"/>
          </a:p>
        </p:txBody>
      </p:sp>
      <p:sp>
        <p:nvSpPr>
          <p:cNvPr id="45" name="Rectangle 26">
            <a:extLst>
              <a:ext uri="{FF2B5EF4-FFF2-40B4-BE49-F238E27FC236}">
                <a16:creationId xmlns="" xmlns:a16="http://schemas.microsoft.com/office/drawing/2014/main" id="{B558C4C5-D271-FA40-AA4C-E7B51498C0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04472" y="2630501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kumimoji="0" lang="ja-JP" altLang="ja-JP" sz="2800" b="0" i="0" u="none" strike="noStrike" cap="none" normalizeH="0" baseline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Rectangle 27">
            <a:extLst>
              <a:ext uri="{FF2B5EF4-FFF2-40B4-BE49-F238E27FC236}">
                <a16:creationId xmlns="" xmlns:a16="http://schemas.microsoft.com/office/drawing/2014/main" id="{8EA2C7BD-F969-3A4E-9AE9-B036698C10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66485" y="2630501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0" lang="ja-JP" altLang="ja-JP" sz="2800" b="0" i="0" u="none" strike="noStrike" cap="none" normalizeH="0" baseline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Rectangle 28">
            <a:extLst>
              <a:ext uri="{FF2B5EF4-FFF2-40B4-BE49-F238E27FC236}">
                <a16:creationId xmlns="" xmlns:a16="http://schemas.microsoft.com/office/drawing/2014/main" id="{4B50669D-9B41-8941-B727-D33D552B66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28497" y="2630501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.0</a:t>
            </a:r>
            <a:endParaRPr kumimoji="0" lang="ja-JP" altLang="ja-JP" sz="2800" b="0" i="0" u="none" strike="noStrike" cap="none" normalizeH="0" baseline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Rectangle 29">
            <a:extLst>
              <a:ext uri="{FF2B5EF4-FFF2-40B4-BE49-F238E27FC236}">
                <a16:creationId xmlns="" xmlns:a16="http://schemas.microsoft.com/office/drawing/2014/main" id="{D4C7BBF4-5409-A640-8E74-12F63F9355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92097" y="2630501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.0</a:t>
            </a:r>
            <a:endParaRPr kumimoji="0" lang="ja-JP" altLang="ja-JP" sz="2800" b="0" i="0" u="none" strike="noStrike" cap="none" normalizeH="0" baseline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2">
            <a:extLst>
              <a:ext uri="{FF2B5EF4-FFF2-40B4-BE49-F238E27FC236}">
                <a16:creationId xmlns="" xmlns:a16="http://schemas.microsoft.com/office/drawing/2014/main" id="{441D9E80-AA9A-8C4E-9CBC-04140F11D90C}"/>
              </a:ext>
            </a:extLst>
          </p:cNvPr>
          <p:cNvSpPr txBox="1"/>
          <p:nvPr/>
        </p:nvSpPr>
        <p:spPr>
          <a:xfrm>
            <a:off x="1580972" y="2790378"/>
            <a:ext cx="369605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centrations of eliminated cumene hydroperoxide (mM)  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Freeform 29">
            <a:extLst>
              <a:ext uri="{FF2B5EF4-FFF2-40B4-BE49-F238E27FC236}">
                <a16:creationId xmlns="" xmlns:a16="http://schemas.microsoft.com/office/drawing/2014/main" id="{6CBFEF61-7BCE-5C44-BE37-56D094DEC4F6}"/>
              </a:ext>
            </a:extLst>
          </p:cNvPr>
          <p:cNvSpPr>
            <a:spLocks noEditPoints="1"/>
          </p:cNvSpPr>
          <p:nvPr/>
        </p:nvSpPr>
        <p:spPr bwMode="auto">
          <a:xfrm>
            <a:off x="4040143" y="1897209"/>
            <a:ext cx="437512" cy="46022"/>
          </a:xfrm>
          <a:custGeom>
            <a:avLst/>
            <a:gdLst>
              <a:gd name="T0" fmla="*/ 335 w 669"/>
              <a:gd name="T1" fmla="*/ 39 h 70"/>
              <a:gd name="T2" fmla="*/ 6 w 669"/>
              <a:gd name="T3" fmla="*/ 39 h 70"/>
              <a:gd name="T4" fmla="*/ 6 w 669"/>
              <a:gd name="T5" fmla="*/ 28 h 70"/>
              <a:gd name="T6" fmla="*/ 335 w 669"/>
              <a:gd name="T7" fmla="*/ 28 h 70"/>
              <a:gd name="T8" fmla="*/ 335 w 669"/>
              <a:gd name="T9" fmla="*/ 39 h 70"/>
              <a:gd name="T10" fmla="*/ 335 w 669"/>
              <a:gd name="T11" fmla="*/ 28 h 70"/>
              <a:gd name="T12" fmla="*/ 664 w 669"/>
              <a:gd name="T13" fmla="*/ 28 h 70"/>
              <a:gd name="T14" fmla="*/ 664 w 669"/>
              <a:gd name="T15" fmla="*/ 39 h 70"/>
              <a:gd name="T16" fmla="*/ 335 w 669"/>
              <a:gd name="T17" fmla="*/ 39 h 70"/>
              <a:gd name="T18" fmla="*/ 335 w 669"/>
              <a:gd name="T19" fmla="*/ 28 h 70"/>
              <a:gd name="T20" fmla="*/ 12 w 669"/>
              <a:gd name="T21" fmla="*/ 0 h 70"/>
              <a:gd name="T22" fmla="*/ 12 w 669"/>
              <a:gd name="T23" fmla="*/ 70 h 70"/>
              <a:gd name="T24" fmla="*/ 0 w 669"/>
              <a:gd name="T25" fmla="*/ 70 h 70"/>
              <a:gd name="T26" fmla="*/ 0 w 669"/>
              <a:gd name="T27" fmla="*/ 0 h 70"/>
              <a:gd name="T28" fmla="*/ 12 w 669"/>
              <a:gd name="T29" fmla="*/ 0 h 70"/>
              <a:gd name="T30" fmla="*/ 669 w 669"/>
              <a:gd name="T31" fmla="*/ 0 h 70"/>
              <a:gd name="T32" fmla="*/ 669 w 669"/>
              <a:gd name="T33" fmla="*/ 70 h 70"/>
              <a:gd name="T34" fmla="*/ 658 w 669"/>
              <a:gd name="T35" fmla="*/ 70 h 70"/>
              <a:gd name="T36" fmla="*/ 658 w 669"/>
              <a:gd name="T37" fmla="*/ 0 h 70"/>
              <a:gd name="T38" fmla="*/ 669 w 669"/>
              <a:gd name="T39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669" h="70">
                <a:moveTo>
                  <a:pt x="335" y="39"/>
                </a:moveTo>
                <a:lnTo>
                  <a:pt x="6" y="39"/>
                </a:lnTo>
                <a:lnTo>
                  <a:pt x="6" y="28"/>
                </a:lnTo>
                <a:lnTo>
                  <a:pt x="335" y="28"/>
                </a:lnTo>
                <a:lnTo>
                  <a:pt x="335" y="39"/>
                </a:lnTo>
                <a:close/>
                <a:moveTo>
                  <a:pt x="335" y="28"/>
                </a:moveTo>
                <a:lnTo>
                  <a:pt x="664" y="28"/>
                </a:lnTo>
                <a:lnTo>
                  <a:pt x="664" y="39"/>
                </a:lnTo>
                <a:lnTo>
                  <a:pt x="335" y="39"/>
                </a:lnTo>
                <a:lnTo>
                  <a:pt x="335" y="28"/>
                </a:lnTo>
                <a:close/>
                <a:moveTo>
                  <a:pt x="12" y="0"/>
                </a:moveTo>
                <a:lnTo>
                  <a:pt x="12" y="70"/>
                </a:lnTo>
                <a:lnTo>
                  <a:pt x="0" y="70"/>
                </a:lnTo>
                <a:lnTo>
                  <a:pt x="0" y="0"/>
                </a:lnTo>
                <a:lnTo>
                  <a:pt x="12" y="0"/>
                </a:lnTo>
                <a:close/>
                <a:moveTo>
                  <a:pt x="669" y="0"/>
                </a:moveTo>
                <a:lnTo>
                  <a:pt x="669" y="70"/>
                </a:lnTo>
                <a:lnTo>
                  <a:pt x="658" y="70"/>
                </a:lnTo>
                <a:lnTo>
                  <a:pt x="658" y="0"/>
                </a:lnTo>
                <a:lnTo>
                  <a:pt x="669" y="0"/>
                </a:lnTo>
                <a:close/>
              </a:path>
            </a:pathLst>
          </a:custGeom>
          <a:solidFill>
            <a:srgbClr val="595959"/>
          </a:solidFill>
          <a:ln w="1588">
            <a:solidFill>
              <a:srgbClr val="595959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" name="Freeform 26">
            <a:extLst>
              <a:ext uri="{FF2B5EF4-FFF2-40B4-BE49-F238E27FC236}">
                <a16:creationId xmlns="" xmlns:a16="http://schemas.microsoft.com/office/drawing/2014/main" id="{C998118F-E487-0D41-B4DE-0319C6D40CD3}"/>
              </a:ext>
            </a:extLst>
          </p:cNvPr>
          <p:cNvSpPr>
            <a:spLocks noEditPoints="1"/>
          </p:cNvSpPr>
          <p:nvPr/>
        </p:nvSpPr>
        <p:spPr bwMode="auto">
          <a:xfrm>
            <a:off x="1949515" y="1527055"/>
            <a:ext cx="2621145" cy="1056572"/>
          </a:xfrm>
          <a:custGeom>
            <a:avLst/>
            <a:gdLst>
              <a:gd name="T0" fmla="*/ 0 w 4003"/>
              <a:gd name="T1" fmla="*/ 6 h 2571"/>
              <a:gd name="T2" fmla="*/ 0 w 4003"/>
              <a:gd name="T3" fmla="*/ 0 h 2571"/>
              <a:gd name="T4" fmla="*/ 6 w 4003"/>
              <a:gd name="T5" fmla="*/ 0 h 2571"/>
              <a:gd name="T6" fmla="*/ 3997 w 4003"/>
              <a:gd name="T7" fmla="*/ 0 h 2571"/>
              <a:gd name="T8" fmla="*/ 4001 w 4003"/>
              <a:gd name="T9" fmla="*/ 0 h 2571"/>
              <a:gd name="T10" fmla="*/ 4003 w 4003"/>
              <a:gd name="T11" fmla="*/ 6 h 2571"/>
              <a:gd name="T12" fmla="*/ 4003 w 4003"/>
              <a:gd name="T13" fmla="*/ 2565 h 2571"/>
              <a:gd name="T14" fmla="*/ 4001 w 4003"/>
              <a:gd name="T15" fmla="*/ 2569 h 2571"/>
              <a:gd name="T16" fmla="*/ 3997 w 4003"/>
              <a:gd name="T17" fmla="*/ 2571 h 2571"/>
              <a:gd name="T18" fmla="*/ 6 w 4003"/>
              <a:gd name="T19" fmla="*/ 2571 h 2571"/>
              <a:gd name="T20" fmla="*/ 0 w 4003"/>
              <a:gd name="T21" fmla="*/ 2569 h 2571"/>
              <a:gd name="T22" fmla="*/ 0 w 4003"/>
              <a:gd name="T23" fmla="*/ 2565 h 2571"/>
              <a:gd name="T24" fmla="*/ 0 w 4003"/>
              <a:gd name="T25" fmla="*/ 6 h 2571"/>
              <a:gd name="T26" fmla="*/ 12 w 4003"/>
              <a:gd name="T27" fmla="*/ 2565 h 2571"/>
              <a:gd name="T28" fmla="*/ 6 w 4003"/>
              <a:gd name="T29" fmla="*/ 2560 h 2571"/>
              <a:gd name="T30" fmla="*/ 3997 w 4003"/>
              <a:gd name="T31" fmla="*/ 2560 h 2571"/>
              <a:gd name="T32" fmla="*/ 3992 w 4003"/>
              <a:gd name="T33" fmla="*/ 2565 h 2571"/>
              <a:gd name="T34" fmla="*/ 3992 w 4003"/>
              <a:gd name="T35" fmla="*/ 6 h 2571"/>
              <a:gd name="T36" fmla="*/ 3997 w 4003"/>
              <a:gd name="T37" fmla="*/ 12 h 2571"/>
              <a:gd name="T38" fmla="*/ 6 w 4003"/>
              <a:gd name="T39" fmla="*/ 12 h 2571"/>
              <a:gd name="T40" fmla="*/ 12 w 4003"/>
              <a:gd name="T41" fmla="*/ 6 h 2571"/>
              <a:gd name="T42" fmla="*/ 12 w 4003"/>
              <a:gd name="T43" fmla="*/ 2565 h 25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</a:cxnLst>
            <a:rect l="0" t="0" r="r" b="b"/>
            <a:pathLst>
              <a:path w="4003" h="2571">
                <a:moveTo>
                  <a:pt x="0" y="6"/>
                </a:moveTo>
                <a:lnTo>
                  <a:pt x="0" y="0"/>
                </a:lnTo>
                <a:lnTo>
                  <a:pt x="6" y="0"/>
                </a:lnTo>
                <a:lnTo>
                  <a:pt x="3997" y="0"/>
                </a:lnTo>
                <a:lnTo>
                  <a:pt x="4001" y="0"/>
                </a:lnTo>
                <a:lnTo>
                  <a:pt x="4003" y="6"/>
                </a:lnTo>
                <a:lnTo>
                  <a:pt x="4003" y="2565"/>
                </a:lnTo>
                <a:lnTo>
                  <a:pt x="4001" y="2569"/>
                </a:lnTo>
                <a:lnTo>
                  <a:pt x="3997" y="2571"/>
                </a:lnTo>
                <a:lnTo>
                  <a:pt x="6" y="2571"/>
                </a:lnTo>
                <a:lnTo>
                  <a:pt x="0" y="2569"/>
                </a:lnTo>
                <a:lnTo>
                  <a:pt x="0" y="2565"/>
                </a:lnTo>
                <a:lnTo>
                  <a:pt x="0" y="6"/>
                </a:lnTo>
                <a:close/>
                <a:moveTo>
                  <a:pt x="12" y="2565"/>
                </a:moveTo>
                <a:lnTo>
                  <a:pt x="6" y="2560"/>
                </a:lnTo>
                <a:lnTo>
                  <a:pt x="3997" y="2560"/>
                </a:lnTo>
                <a:lnTo>
                  <a:pt x="3992" y="2565"/>
                </a:lnTo>
                <a:lnTo>
                  <a:pt x="3992" y="6"/>
                </a:lnTo>
                <a:lnTo>
                  <a:pt x="3997" y="12"/>
                </a:lnTo>
                <a:lnTo>
                  <a:pt x="6" y="12"/>
                </a:lnTo>
                <a:lnTo>
                  <a:pt x="12" y="6"/>
                </a:lnTo>
                <a:lnTo>
                  <a:pt x="12" y="2565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6" name="Freeform 12">
            <a:extLst>
              <a:ext uri="{FF2B5EF4-FFF2-40B4-BE49-F238E27FC236}">
                <a16:creationId xmlns="" xmlns:a16="http://schemas.microsoft.com/office/drawing/2014/main" id="{FCD0C29B-78EA-2444-807C-BE67887292C7}"/>
              </a:ext>
            </a:extLst>
          </p:cNvPr>
          <p:cNvSpPr>
            <a:spLocks noEditPoints="1"/>
          </p:cNvSpPr>
          <p:nvPr/>
        </p:nvSpPr>
        <p:spPr bwMode="auto">
          <a:xfrm>
            <a:off x="1982662" y="2210461"/>
            <a:ext cx="17029" cy="46022"/>
          </a:xfrm>
          <a:custGeom>
            <a:avLst/>
            <a:gdLst>
              <a:gd name="T0" fmla="*/ 13 w 27"/>
              <a:gd name="T1" fmla="*/ 40 h 70"/>
              <a:gd name="T2" fmla="*/ 6 w 27"/>
              <a:gd name="T3" fmla="*/ 40 h 70"/>
              <a:gd name="T4" fmla="*/ 6 w 27"/>
              <a:gd name="T5" fmla="*/ 29 h 70"/>
              <a:gd name="T6" fmla="*/ 13 w 27"/>
              <a:gd name="T7" fmla="*/ 29 h 70"/>
              <a:gd name="T8" fmla="*/ 13 w 27"/>
              <a:gd name="T9" fmla="*/ 40 h 70"/>
              <a:gd name="T10" fmla="*/ 13 w 27"/>
              <a:gd name="T11" fmla="*/ 29 h 70"/>
              <a:gd name="T12" fmla="*/ 21 w 27"/>
              <a:gd name="T13" fmla="*/ 29 h 70"/>
              <a:gd name="T14" fmla="*/ 21 w 27"/>
              <a:gd name="T15" fmla="*/ 40 h 70"/>
              <a:gd name="T16" fmla="*/ 13 w 27"/>
              <a:gd name="T17" fmla="*/ 40 h 70"/>
              <a:gd name="T18" fmla="*/ 13 w 27"/>
              <a:gd name="T19" fmla="*/ 29 h 70"/>
              <a:gd name="T20" fmla="*/ 12 w 27"/>
              <a:gd name="T21" fmla="*/ 0 h 70"/>
              <a:gd name="T22" fmla="*/ 12 w 27"/>
              <a:gd name="T23" fmla="*/ 70 h 70"/>
              <a:gd name="T24" fmla="*/ 0 w 27"/>
              <a:gd name="T25" fmla="*/ 70 h 70"/>
              <a:gd name="T26" fmla="*/ 0 w 27"/>
              <a:gd name="T27" fmla="*/ 0 h 70"/>
              <a:gd name="T28" fmla="*/ 12 w 27"/>
              <a:gd name="T29" fmla="*/ 0 h 70"/>
              <a:gd name="T30" fmla="*/ 27 w 27"/>
              <a:gd name="T31" fmla="*/ 0 h 70"/>
              <a:gd name="T32" fmla="*/ 27 w 27"/>
              <a:gd name="T33" fmla="*/ 70 h 70"/>
              <a:gd name="T34" fmla="*/ 15 w 27"/>
              <a:gd name="T35" fmla="*/ 70 h 70"/>
              <a:gd name="T36" fmla="*/ 15 w 27"/>
              <a:gd name="T37" fmla="*/ 0 h 70"/>
              <a:gd name="T38" fmla="*/ 27 w 27"/>
              <a:gd name="T39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27" h="70">
                <a:moveTo>
                  <a:pt x="13" y="40"/>
                </a:moveTo>
                <a:lnTo>
                  <a:pt x="6" y="40"/>
                </a:lnTo>
                <a:lnTo>
                  <a:pt x="6" y="29"/>
                </a:lnTo>
                <a:lnTo>
                  <a:pt x="13" y="29"/>
                </a:lnTo>
                <a:lnTo>
                  <a:pt x="13" y="40"/>
                </a:lnTo>
                <a:close/>
                <a:moveTo>
                  <a:pt x="13" y="29"/>
                </a:moveTo>
                <a:lnTo>
                  <a:pt x="21" y="29"/>
                </a:lnTo>
                <a:lnTo>
                  <a:pt x="21" y="40"/>
                </a:lnTo>
                <a:lnTo>
                  <a:pt x="13" y="40"/>
                </a:lnTo>
                <a:lnTo>
                  <a:pt x="13" y="29"/>
                </a:lnTo>
                <a:close/>
                <a:moveTo>
                  <a:pt x="12" y="0"/>
                </a:moveTo>
                <a:lnTo>
                  <a:pt x="12" y="70"/>
                </a:lnTo>
                <a:lnTo>
                  <a:pt x="0" y="70"/>
                </a:lnTo>
                <a:lnTo>
                  <a:pt x="0" y="0"/>
                </a:lnTo>
                <a:lnTo>
                  <a:pt x="12" y="0"/>
                </a:lnTo>
                <a:close/>
                <a:moveTo>
                  <a:pt x="27" y="0"/>
                </a:moveTo>
                <a:lnTo>
                  <a:pt x="27" y="70"/>
                </a:lnTo>
                <a:lnTo>
                  <a:pt x="15" y="70"/>
                </a:lnTo>
                <a:lnTo>
                  <a:pt x="15" y="0"/>
                </a:lnTo>
                <a:lnTo>
                  <a:pt x="27" y="0"/>
                </a:lnTo>
                <a:close/>
              </a:path>
            </a:pathLst>
          </a:custGeom>
          <a:solidFill>
            <a:srgbClr val="595959"/>
          </a:solidFill>
          <a:ln w="1588">
            <a:solidFill>
              <a:srgbClr val="595959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0" name="テキスト ボックス 2">
            <a:extLst>
              <a:ext uri="{FF2B5EF4-FFF2-40B4-BE49-F238E27FC236}">
                <a16:creationId xmlns="" xmlns:a16="http://schemas.microsoft.com/office/drawing/2014/main" id="{25727E24-9F87-4A4E-AD4C-547F4602FD69}"/>
              </a:ext>
            </a:extLst>
          </p:cNvPr>
          <p:cNvSpPr txBox="1"/>
          <p:nvPr/>
        </p:nvSpPr>
        <p:spPr>
          <a:xfrm>
            <a:off x="985500" y="1778970"/>
            <a:ext cx="13141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fore heating</a:t>
            </a:r>
          </a:p>
        </p:txBody>
      </p:sp>
      <p:sp>
        <p:nvSpPr>
          <p:cNvPr id="71" name="テキスト ボックス 2">
            <a:extLst>
              <a:ext uri="{FF2B5EF4-FFF2-40B4-BE49-F238E27FC236}">
                <a16:creationId xmlns="" xmlns:a16="http://schemas.microsoft.com/office/drawing/2014/main" id="{3ACDB316-2555-3E49-B455-3EA083C12CB8}"/>
              </a:ext>
            </a:extLst>
          </p:cNvPr>
          <p:cNvSpPr txBox="1"/>
          <p:nvPr/>
        </p:nvSpPr>
        <p:spPr>
          <a:xfrm>
            <a:off x="1019608" y="2073930"/>
            <a:ext cx="934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heating 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Rectangle 42">
            <a:extLst>
              <a:ext uri="{FF2B5EF4-FFF2-40B4-BE49-F238E27FC236}">
                <a16:creationId xmlns="" xmlns:a16="http://schemas.microsoft.com/office/drawing/2014/main" id="{061F45FE-FB83-094A-8A23-E75E254580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83914" y="4700454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00</a:t>
            </a:r>
            <a:endParaRPr kumimoji="0" lang="ja-JP" altLang="ja-JP" sz="2800" b="0" i="0" u="none" strike="noStrike" cap="none" normalizeH="0" baseline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Rectangle 43">
            <a:extLst>
              <a:ext uri="{FF2B5EF4-FFF2-40B4-BE49-F238E27FC236}">
                <a16:creationId xmlns="" xmlns:a16="http://schemas.microsoft.com/office/drawing/2014/main" id="{29B59BB9-2326-6B45-A045-3D0D56B014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25264" y="4700454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25</a:t>
            </a:r>
            <a:endParaRPr kumimoji="0" lang="ja-JP" altLang="ja-JP" sz="2800" b="0" i="0" u="none" strike="noStrike" cap="none" normalizeH="0" baseline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Rectangle 44">
            <a:extLst>
              <a:ext uri="{FF2B5EF4-FFF2-40B4-BE49-F238E27FC236}">
                <a16:creationId xmlns="" xmlns:a16="http://schemas.microsoft.com/office/drawing/2014/main" id="{791844BB-DA47-3A46-8AAF-89AFB6A7B7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68201" y="4700454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50</a:t>
            </a:r>
            <a:endParaRPr kumimoji="0" lang="ja-JP" altLang="ja-JP" sz="2800" b="0" i="0" u="none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Rectangle 45">
            <a:extLst>
              <a:ext uri="{FF2B5EF4-FFF2-40B4-BE49-F238E27FC236}">
                <a16:creationId xmlns="" xmlns:a16="http://schemas.microsoft.com/office/drawing/2014/main" id="{5BE17726-9EB1-424A-9DF3-7136768540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09551" y="4700454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75</a:t>
            </a:r>
            <a:endParaRPr kumimoji="0" lang="ja-JP" altLang="ja-JP" sz="2800" b="0" i="0" u="none" strike="noStrike" cap="none" normalizeH="0" baseline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Rectangle 46">
            <a:extLst>
              <a:ext uri="{FF2B5EF4-FFF2-40B4-BE49-F238E27FC236}">
                <a16:creationId xmlns="" xmlns:a16="http://schemas.microsoft.com/office/drawing/2014/main" id="{F39CB66F-962D-6C42-9733-3376615994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50901" y="4700454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00</a:t>
            </a:r>
            <a:endParaRPr kumimoji="0" lang="ja-JP" altLang="ja-JP" sz="2800" b="0" i="0" u="none" strike="noStrike" cap="none" normalizeH="0" baseline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テキスト ボックス 2">
            <a:extLst>
              <a:ext uri="{FF2B5EF4-FFF2-40B4-BE49-F238E27FC236}">
                <a16:creationId xmlns="" xmlns:a16="http://schemas.microsoft.com/office/drawing/2014/main" id="{88E0A8F8-7494-7D4A-B7C7-12ED144882DF}"/>
              </a:ext>
            </a:extLst>
          </p:cNvPr>
          <p:cNvSpPr txBox="1"/>
          <p:nvPr/>
        </p:nvSpPr>
        <p:spPr>
          <a:xfrm>
            <a:off x="1544593" y="4841112"/>
            <a:ext cx="39576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centrations of eliminated linoleic acid hydroperoxide (mM)  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Freeform 7">
            <a:extLst>
              <a:ext uri="{FF2B5EF4-FFF2-40B4-BE49-F238E27FC236}">
                <a16:creationId xmlns="" xmlns:a16="http://schemas.microsoft.com/office/drawing/2014/main" id="{2D913CE9-E851-2649-BBD7-96C75B5BCC4C}"/>
              </a:ext>
            </a:extLst>
          </p:cNvPr>
          <p:cNvSpPr>
            <a:spLocks noEditPoints="1"/>
          </p:cNvSpPr>
          <p:nvPr/>
        </p:nvSpPr>
        <p:spPr bwMode="auto">
          <a:xfrm>
            <a:off x="1955944" y="3566684"/>
            <a:ext cx="2600186" cy="1063391"/>
          </a:xfrm>
          <a:custGeom>
            <a:avLst/>
            <a:gdLst>
              <a:gd name="T0" fmla="*/ 0 w 3970"/>
              <a:gd name="T1" fmla="*/ 5 h 2572"/>
              <a:gd name="T2" fmla="*/ 1 w 3970"/>
              <a:gd name="T3" fmla="*/ 2 h 2572"/>
              <a:gd name="T4" fmla="*/ 5 w 3970"/>
              <a:gd name="T5" fmla="*/ 0 h 2572"/>
              <a:gd name="T6" fmla="*/ 3965 w 3970"/>
              <a:gd name="T7" fmla="*/ 0 h 2572"/>
              <a:gd name="T8" fmla="*/ 3968 w 3970"/>
              <a:gd name="T9" fmla="*/ 2 h 2572"/>
              <a:gd name="T10" fmla="*/ 3970 w 3970"/>
              <a:gd name="T11" fmla="*/ 5 h 2572"/>
              <a:gd name="T12" fmla="*/ 3970 w 3970"/>
              <a:gd name="T13" fmla="*/ 2566 h 2572"/>
              <a:gd name="T14" fmla="*/ 3968 w 3970"/>
              <a:gd name="T15" fmla="*/ 2570 h 2572"/>
              <a:gd name="T16" fmla="*/ 3965 w 3970"/>
              <a:gd name="T17" fmla="*/ 2572 h 2572"/>
              <a:gd name="T18" fmla="*/ 5 w 3970"/>
              <a:gd name="T19" fmla="*/ 2572 h 2572"/>
              <a:gd name="T20" fmla="*/ 1 w 3970"/>
              <a:gd name="T21" fmla="*/ 2570 h 2572"/>
              <a:gd name="T22" fmla="*/ 0 w 3970"/>
              <a:gd name="T23" fmla="*/ 2566 h 2572"/>
              <a:gd name="T24" fmla="*/ 0 w 3970"/>
              <a:gd name="T25" fmla="*/ 5 h 2572"/>
              <a:gd name="T26" fmla="*/ 11 w 3970"/>
              <a:gd name="T27" fmla="*/ 2566 h 2572"/>
              <a:gd name="T28" fmla="*/ 5 w 3970"/>
              <a:gd name="T29" fmla="*/ 2561 h 2572"/>
              <a:gd name="T30" fmla="*/ 3965 w 3970"/>
              <a:gd name="T31" fmla="*/ 2561 h 2572"/>
              <a:gd name="T32" fmla="*/ 3959 w 3970"/>
              <a:gd name="T33" fmla="*/ 2566 h 2572"/>
              <a:gd name="T34" fmla="*/ 3959 w 3970"/>
              <a:gd name="T35" fmla="*/ 5 h 2572"/>
              <a:gd name="T36" fmla="*/ 3965 w 3970"/>
              <a:gd name="T37" fmla="*/ 11 h 2572"/>
              <a:gd name="T38" fmla="*/ 5 w 3970"/>
              <a:gd name="T39" fmla="*/ 11 h 2572"/>
              <a:gd name="T40" fmla="*/ 11 w 3970"/>
              <a:gd name="T41" fmla="*/ 5 h 2572"/>
              <a:gd name="T42" fmla="*/ 11 w 3970"/>
              <a:gd name="T43" fmla="*/ 2566 h 25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</a:cxnLst>
            <a:rect l="0" t="0" r="r" b="b"/>
            <a:pathLst>
              <a:path w="3970" h="2572">
                <a:moveTo>
                  <a:pt x="0" y="5"/>
                </a:moveTo>
                <a:lnTo>
                  <a:pt x="1" y="2"/>
                </a:lnTo>
                <a:lnTo>
                  <a:pt x="5" y="0"/>
                </a:lnTo>
                <a:lnTo>
                  <a:pt x="3965" y="0"/>
                </a:lnTo>
                <a:lnTo>
                  <a:pt x="3968" y="2"/>
                </a:lnTo>
                <a:lnTo>
                  <a:pt x="3970" y="5"/>
                </a:lnTo>
                <a:lnTo>
                  <a:pt x="3970" y="2566"/>
                </a:lnTo>
                <a:lnTo>
                  <a:pt x="3968" y="2570"/>
                </a:lnTo>
                <a:lnTo>
                  <a:pt x="3965" y="2572"/>
                </a:lnTo>
                <a:lnTo>
                  <a:pt x="5" y="2572"/>
                </a:lnTo>
                <a:lnTo>
                  <a:pt x="1" y="2570"/>
                </a:lnTo>
                <a:lnTo>
                  <a:pt x="0" y="2566"/>
                </a:lnTo>
                <a:lnTo>
                  <a:pt x="0" y="5"/>
                </a:lnTo>
                <a:close/>
                <a:moveTo>
                  <a:pt x="11" y="2566"/>
                </a:moveTo>
                <a:lnTo>
                  <a:pt x="5" y="2561"/>
                </a:lnTo>
                <a:lnTo>
                  <a:pt x="3965" y="2561"/>
                </a:lnTo>
                <a:lnTo>
                  <a:pt x="3959" y="2566"/>
                </a:lnTo>
                <a:lnTo>
                  <a:pt x="3959" y="5"/>
                </a:lnTo>
                <a:lnTo>
                  <a:pt x="3965" y="11"/>
                </a:lnTo>
                <a:lnTo>
                  <a:pt x="5" y="11"/>
                </a:lnTo>
                <a:lnTo>
                  <a:pt x="11" y="5"/>
                </a:lnTo>
                <a:lnTo>
                  <a:pt x="11" y="2566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" name="テキスト ボックス 2">
            <a:extLst>
              <a:ext uri="{FF2B5EF4-FFF2-40B4-BE49-F238E27FC236}">
                <a16:creationId xmlns="" xmlns:a16="http://schemas.microsoft.com/office/drawing/2014/main" id="{55D46528-1E5F-0C45-AD57-8180B6112F29}"/>
              </a:ext>
            </a:extLst>
          </p:cNvPr>
          <p:cNvSpPr txBox="1"/>
          <p:nvPr/>
        </p:nvSpPr>
        <p:spPr>
          <a:xfrm>
            <a:off x="1002192" y="3811872"/>
            <a:ext cx="13141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fore heating</a:t>
            </a:r>
          </a:p>
        </p:txBody>
      </p:sp>
      <p:sp>
        <p:nvSpPr>
          <p:cNvPr id="90" name="テキスト ボックス 2">
            <a:extLst>
              <a:ext uri="{FF2B5EF4-FFF2-40B4-BE49-F238E27FC236}">
                <a16:creationId xmlns="" xmlns:a16="http://schemas.microsoft.com/office/drawing/2014/main" id="{951E1757-E3B9-264E-BBA3-7B0E0E104D97}"/>
              </a:ext>
            </a:extLst>
          </p:cNvPr>
          <p:cNvSpPr txBox="1"/>
          <p:nvPr/>
        </p:nvSpPr>
        <p:spPr>
          <a:xfrm>
            <a:off x="1057067" y="4113497"/>
            <a:ext cx="9343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heating 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Freeform 12">
            <a:extLst>
              <a:ext uri="{FF2B5EF4-FFF2-40B4-BE49-F238E27FC236}">
                <a16:creationId xmlns="" xmlns:a16="http://schemas.microsoft.com/office/drawing/2014/main" id="{16E20553-18EF-EF4F-A248-5EF984FD67EB}"/>
              </a:ext>
            </a:extLst>
          </p:cNvPr>
          <p:cNvSpPr>
            <a:spLocks noEditPoints="1"/>
          </p:cNvSpPr>
          <p:nvPr/>
        </p:nvSpPr>
        <p:spPr bwMode="auto">
          <a:xfrm>
            <a:off x="1990896" y="4245252"/>
            <a:ext cx="17029" cy="46022"/>
          </a:xfrm>
          <a:custGeom>
            <a:avLst/>
            <a:gdLst>
              <a:gd name="T0" fmla="*/ 13 w 27"/>
              <a:gd name="T1" fmla="*/ 40 h 70"/>
              <a:gd name="T2" fmla="*/ 6 w 27"/>
              <a:gd name="T3" fmla="*/ 40 h 70"/>
              <a:gd name="T4" fmla="*/ 6 w 27"/>
              <a:gd name="T5" fmla="*/ 29 h 70"/>
              <a:gd name="T6" fmla="*/ 13 w 27"/>
              <a:gd name="T7" fmla="*/ 29 h 70"/>
              <a:gd name="T8" fmla="*/ 13 w 27"/>
              <a:gd name="T9" fmla="*/ 40 h 70"/>
              <a:gd name="T10" fmla="*/ 13 w 27"/>
              <a:gd name="T11" fmla="*/ 29 h 70"/>
              <a:gd name="T12" fmla="*/ 21 w 27"/>
              <a:gd name="T13" fmla="*/ 29 h 70"/>
              <a:gd name="T14" fmla="*/ 21 w 27"/>
              <a:gd name="T15" fmla="*/ 40 h 70"/>
              <a:gd name="T16" fmla="*/ 13 w 27"/>
              <a:gd name="T17" fmla="*/ 40 h 70"/>
              <a:gd name="T18" fmla="*/ 13 w 27"/>
              <a:gd name="T19" fmla="*/ 29 h 70"/>
              <a:gd name="T20" fmla="*/ 12 w 27"/>
              <a:gd name="T21" fmla="*/ 0 h 70"/>
              <a:gd name="T22" fmla="*/ 12 w 27"/>
              <a:gd name="T23" fmla="*/ 70 h 70"/>
              <a:gd name="T24" fmla="*/ 0 w 27"/>
              <a:gd name="T25" fmla="*/ 70 h 70"/>
              <a:gd name="T26" fmla="*/ 0 w 27"/>
              <a:gd name="T27" fmla="*/ 0 h 70"/>
              <a:gd name="T28" fmla="*/ 12 w 27"/>
              <a:gd name="T29" fmla="*/ 0 h 70"/>
              <a:gd name="T30" fmla="*/ 27 w 27"/>
              <a:gd name="T31" fmla="*/ 0 h 70"/>
              <a:gd name="T32" fmla="*/ 27 w 27"/>
              <a:gd name="T33" fmla="*/ 70 h 70"/>
              <a:gd name="T34" fmla="*/ 15 w 27"/>
              <a:gd name="T35" fmla="*/ 70 h 70"/>
              <a:gd name="T36" fmla="*/ 15 w 27"/>
              <a:gd name="T37" fmla="*/ 0 h 70"/>
              <a:gd name="T38" fmla="*/ 27 w 27"/>
              <a:gd name="T39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27" h="70">
                <a:moveTo>
                  <a:pt x="13" y="40"/>
                </a:moveTo>
                <a:lnTo>
                  <a:pt x="6" y="40"/>
                </a:lnTo>
                <a:lnTo>
                  <a:pt x="6" y="29"/>
                </a:lnTo>
                <a:lnTo>
                  <a:pt x="13" y="29"/>
                </a:lnTo>
                <a:lnTo>
                  <a:pt x="13" y="40"/>
                </a:lnTo>
                <a:close/>
                <a:moveTo>
                  <a:pt x="13" y="29"/>
                </a:moveTo>
                <a:lnTo>
                  <a:pt x="21" y="29"/>
                </a:lnTo>
                <a:lnTo>
                  <a:pt x="21" y="40"/>
                </a:lnTo>
                <a:lnTo>
                  <a:pt x="13" y="40"/>
                </a:lnTo>
                <a:lnTo>
                  <a:pt x="13" y="29"/>
                </a:lnTo>
                <a:close/>
                <a:moveTo>
                  <a:pt x="12" y="0"/>
                </a:moveTo>
                <a:lnTo>
                  <a:pt x="12" y="70"/>
                </a:lnTo>
                <a:lnTo>
                  <a:pt x="0" y="70"/>
                </a:lnTo>
                <a:lnTo>
                  <a:pt x="0" y="0"/>
                </a:lnTo>
                <a:lnTo>
                  <a:pt x="12" y="0"/>
                </a:lnTo>
                <a:close/>
                <a:moveTo>
                  <a:pt x="27" y="0"/>
                </a:moveTo>
                <a:lnTo>
                  <a:pt x="27" y="70"/>
                </a:lnTo>
                <a:lnTo>
                  <a:pt x="15" y="70"/>
                </a:lnTo>
                <a:lnTo>
                  <a:pt x="15" y="0"/>
                </a:lnTo>
                <a:lnTo>
                  <a:pt x="27" y="0"/>
                </a:lnTo>
                <a:close/>
              </a:path>
            </a:pathLst>
          </a:custGeom>
          <a:solidFill>
            <a:srgbClr val="595959"/>
          </a:solidFill>
          <a:ln w="1588">
            <a:solidFill>
              <a:srgbClr val="595959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4" name="Freeform 10">
            <a:extLst>
              <a:ext uri="{FF2B5EF4-FFF2-40B4-BE49-F238E27FC236}">
                <a16:creationId xmlns="" xmlns:a16="http://schemas.microsoft.com/office/drawing/2014/main" id="{79F811CC-5B55-8D45-8BDD-C68FEED67FE0}"/>
              </a:ext>
            </a:extLst>
          </p:cNvPr>
          <p:cNvSpPr>
            <a:spLocks noEditPoints="1"/>
          </p:cNvSpPr>
          <p:nvPr/>
        </p:nvSpPr>
        <p:spPr bwMode="auto">
          <a:xfrm>
            <a:off x="3195126" y="3941181"/>
            <a:ext cx="725694" cy="44707"/>
          </a:xfrm>
          <a:custGeom>
            <a:avLst/>
            <a:gdLst>
              <a:gd name="T0" fmla="*/ 554 w 1110"/>
              <a:gd name="T1" fmla="*/ 42 h 70"/>
              <a:gd name="T2" fmla="*/ 6 w 1110"/>
              <a:gd name="T3" fmla="*/ 42 h 70"/>
              <a:gd name="T4" fmla="*/ 6 w 1110"/>
              <a:gd name="T5" fmla="*/ 30 h 70"/>
              <a:gd name="T6" fmla="*/ 554 w 1110"/>
              <a:gd name="T7" fmla="*/ 30 h 70"/>
              <a:gd name="T8" fmla="*/ 554 w 1110"/>
              <a:gd name="T9" fmla="*/ 42 h 70"/>
              <a:gd name="T10" fmla="*/ 554 w 1110"/>
              <a:gd name="T11" fmla="*/ 30 h 70"/>
              <a:gd name="T12" fmla="*/ 1104 w 1110"/>
              <a:gd name="T13" fmla="*/ 30 h 70"/>
              <a:gd name="T14" fmla="*/ 1104 w 1110"/>
              <a:gd name="T15" fmla="*/ 42 h 70"/>
              <a:gd name="T16" fmla="*/ 554 w 1110"/>
              <a:gd name="T17" fmla="*/ 42 h 70"/>
              <a:gd name="T18" fmla="*/ 554 w 1110"/>
              <a:gd name="T19" fmla="*/ 30 h 70"/>
              <a:gd name="T20" fmla="*/ 12 w 1110"/>
              <a:gd name="T21" fmla="*/ 0 h 70"/>
              <a:gd name="T22" fmla="*/ 12 w 1110"/>
              <a:gd name="T23" fmla="*/ 70 h 70"/>
              <a:gd name="T24" fmla="*/ 0 w 1110"/>
              <a:gd name="T25" fmla="*/ 70 h 70"/>
              <a:gd name="T26" fmla="*/ 0 w 1110"/>
              <a:gd name="T27" fmla="*/ 0 h 70"/>
              <a:gd name="T28" fmla="*/ 12 w 1110"/>
              <a:gd name="T29" fmla="*/ 0 h 70"/>
              <a:gd name="T30" fmla="*/ 1110 w 1110"/>
              <a:gd name="T31" fmla="*/ 0 h 70"/>
              <a:gd name="T32" fmla="*/ 1110 w 1110"/>
              <a:gd name="T33" fmla="*/ 70 h 70"/>
              <a:gd name="T34" fmla="*/ 1098 w 1110"/>
              <a:gd name="T35" fmla="*/ 70 h 70"/>
              <a:gd name="T36" fmla="*/ 1098 w 1110"/>
              <a:gd name="T37" fmla="*/ 0 h 70"/>
              <a:gd name="T38" fmla="*/ 1110 w 1110"/>
              <a:gd name="T39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1110" h="70">
                <a:moveTo>
                  <a:pt x="554" y="42"/>
                </a:moveTo>
                <a:lnTo>
                  <a:pt x="6" y="42"/>
                </a:lnTo>
                <a:lnTo>
                  <a:pt x="6" y="30"/>
                </a:lnTo>
                <a:lnTo>
                  <a:pt x="554" y="30"/>
                </a:lnTo>
                <a:lnTo>
                  <a:pt x="554" y="42"/>
                </a:lnTo>
                <a:close/>
                <a:moveTo>
                  <a:pt x="554" y="30"/>
                </a:moveTo>
                <a:lnTo>
                  <a:pt x="1104" y="30"/>
                </a:lnTo>
                <a:lnTo>
                  <a:pt x="1104" y="42"/>
                </a:lnTo>
                <a:lnTo>
                  <a:pt x="554" y="42"/>
                </a:lnTo>
                <a:lnTo>
                  <a:pt x="554" y="30"/>
                </a:lnTo>
                <a:close/>
                <a:moveTo>
                  <a:pt x="12" y="0"/>
                </a:moveTo>
                <a:lnTo>
                  <a:pt x="12" y="70"/>
                </a:lnTo>
                <a:lnTo>
                  <a:pt x="0" y="70"/>
                </a:lnTo>
                <a:lnTo>
                  <a:pt x="0" y="0"/>
                </a:lnTo>
                <a:lnTo>
                  <a:pt x="12" y="0"/>
                </a:lnTo>
                <a:close/>
                <a:moveTo>
                  <a:pt x="1110" y="0"/>
                </a:moveTo>
                <a:lnTo>
                  <a:pt x="1110" y="70"/>
                </a:lnTo>
                <a:lnTo>
                  <a:pt x="1098" y="70"/>
                </a:lnTo>
                <a:lnTo>
                  <a:pt x="1098" y="0"/>
                </a:lnTo>
                <a:lnTo>
                  <a:pt x="1110" y="0"/>
                </a:lnTo>
                <a:close/>
              </a:path>
            </a:pathLst>
          </a:custGeom>
          <a:solidFill>
            <a:srgbClr val="595959"/>
          </a:solidFill>
          <a:ln w="1588">
            <a:solidFill>
              <a:srgbClr val="595959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cxnSp>
        <p:nvCxnSpPr>
          <p:cNvPr id="94" name="直線コネクタ 93">
            <a:extLst>
              <a:ext uri="{FF2B5EF4-FFF2-40B4-BE49-F238E27FC236}">
                <a16:creationId xmlns="" xmlns:a16="http://schemas.microsoft.com/office/drawing/2014/main" id="{9776AC9D-C304-7841-9CC3-0DDD59574F48}"/>
              </a:ext>
            </a:extLst>
          </p:cNvPr>
          <p:cNvCxnSpPr>
            <a:cxnSpLocks/>
          </p:cNvCxnSpPr>
          <p:nvPr/>
        </p:nvCxnSpPr>
        <p:spPr>
          <a:xfrm>
            <a:off x="2612201" y="3566684"/>
            <a:ext cx="0" cy="1063391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線コネクタ 95">
            <a:extLst>
              <a:ext uri="{FF2B5EF4-FFF2-40B4-BE49-F238E27FC236}">
                <a16:creationId xmlns="" xmlns:a16="http://schemas.microsoft.com/office/drawing/2014/main" id="{7CDA39F2-DA81-C646-A644-CF4F62A32ACD}"/>
              </a:ext>
            </a:extLst>
          </p:cNvPr>
          <p:cNvCxnSpPr>
            <a:cxnSpLocks/>
          </p:cNvCxnSpPr>
          <p:nvPr/>
        </p:nvCxnSpPr>
        <p:spPr>
          <a:xfrm>
            <a:off x="3259084" y="3566684"/>
            <a:ext cx="0" cy="1063391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線コネクタ 96">
            <a:extLst>
              <a:ext uri="{FF2B5EF4-FFF2-40B4-BE49-F238E27FC236}">
                <a16:creationId xmlns="" xmlns:a16="http://schemas.microsoft.com/office/drawing/2014/main" id="{D4518516-EE0F-B04D-974F-CC2D09CFCEF9}"/>
              </a:ext>
            </a:extLst>
          </p:cNvPr>
          <p:cNvCxnSpPr>
            <a:cxnSpLocks/>
          </p:cNvCxnSpPr>
          <p:nvPr/>
        </p:nvCxnSpPr>
        <p:spPr>
          <a:xfrm>
            <a:off x="3905124" y="3566684"/>
            <a:ext cx="0" cy="1063391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テキスト ボックス 2"/>
          <p:cNvSpPr txBox="1"/>
          <p:nvPr/>
        </p:nvSpPr>
        <p:spPr>
          <a:xfrm>
            <a:off x="2167128" y="3264408"/>
            <a:ext cx="22188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ja-JP" altLang="ja-JP" sz="1400" dirty="0">
                <a:solidFill>
                  <a:srgbClr val="595959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noleic acid hydroperoxide</a:t>
            </a: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210547" y="1169329"/>
            <a:ext cx="18758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/>
            <a:r>
              <a:rPr lang="ja-JP" altLang="ja-JP" sz="1400" dirty="0">
                <a:solidFill>
                  <a:srgbClr val="595959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umene hydroperoxide</a:t>
            </a: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08327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solidFill>
          <a:srgbClr val="7F7F7F"/>
        </a:solidFill>
        <a:ln w="1588" cap="flat">
          <a:solidFill>
            <a:srgbClr val="7F7F7F"/>
          </a:solidFill>
          <a:prstDash val="solid"/>
          <a:bevel/>
          <a:headEnd/>
          <a:tailEnd/>
        </a:ln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algn="l">
          <a:defRPr sz="1000"/>
        </a:defPPr>
      </a:lstStyle>
    </a:spDef>
  </a:objectDefaults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3</TotalTime>
  <Words>69</Words>
  <Application>Microsoft Office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s200588</dc:creator>
  <cp:lastModifiedBy>Arshad Rezwan</cp:lastModifiedBy>
  <cp:revision>67</cp:revision>
  <cp:lastPrinted>2019-06-09T14:07:56Z</cp:lastPrinted>
  <dcterms:created xsi:type="dcterms:W3CDTF">2019-02-21T04:56:07Z</dcterms:created>
  <dcterms:modified xsi:type="dcterms:W3CDTF">2020-02-14T11:12:42Z</dcterms:modified>
</cp:coreProperties>
</file>